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DCA438-8BCC-43DE-BD18-E7F93FC05B5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5BC40E-5BF2-4D73-9835-4DE3E2CDCC5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2"/>
          <p:cNvSpPr/>
          <p:nvPr/>
        </p:nvSpPr>
        <p:spPr>
          <a:xfrm>
            <a:off x="3886200" y="-1440"/>
            <a:ext cx="2971800" cy="45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3"/>
          <p:cNvSpPr/>
          <p:nvPr/>
        </p:nvSpPr>
        <p:spPr>
          <a:xfrm>
            <a:off x="3886200" y="8683560"/>
            <a:ext cx="2971800" cy="46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9080" rIns="19080" tIns="0" bIns="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888840"/>
                <a:tab algn="l" pos="1778040"/>
                <a:tab algn="l" pos="2666880"/>
                <a:tab algn="l" pos="3556080"/>
                <a:tab algn="l" pos="4444920"/>
                <a:tab algn="l" pos="5334120"/>
                <a:tab algn="l" pos="6222960"/>
                <a:tab algn="l" pos="7112160"/>
                <a:tab algn="l" pos="8001000"/>
                <a:tab algn="l" pos="8889840"/>
                <a:tab algn="l" pos="9779040"/>
                <a:tab algn="l" pos="1066788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4"/>
          <p:cNvSpPr/>
          <p:nvPr/>
        </p:nvSpPr>
        <p:spPr>
          <a:xfrm>
            <a:off x="0" y="8683560"/>
            <a:ext cx="2971800" cy="46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5"/>
          <p:cNvSpPr/>
          <p:nvPr/>
        </p:nvSpPr>
        <p:spPr>
          <a:xfrm>
            <a:off x="0" y="-1440"/>
            <a:ext cx="2971800" cy="45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1"/>
          <p:cNvSpPr>
            <a:spLocks noGrp="1"/>
          </p:cNvSpPr>
          <p:nvPr>
            <p:ph type="sldImg"/>
          </p:nvPr>
        </p:nvSpPr>
        <p:spPr>
          <a:xfrm>
            <a:off x="1143000" y="687240"/>
            <a:ext cx="4570560" cy="3427560"/>
          </a:xfrm>
          <a:prstGeom prst="rect">
            <a:avLst/>
          </a:prstGeom>
          <a:ln w="0">
            <a:noFill/>
          </a:ln>
        </p:spPr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9E2994-E1E9-4FDD-AD74-E34EA06856C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2"/>
          <p:cNvSpPr/>
          <p:nvPr/>
        </p:nvSpPr>
        <p:spPr>
          <a:xfrm>
            <a:off x="3886200" y="-1440"/>
            <a:ext cx="2971800" cy="45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3"/>
          <p:cNvSpPr/>
          <p:nvPr/>
        </p:nvSpPr>
        <p:spPr>
          <a:xfrm>
            <a:off x="3886200" y="8683560"/>
            <a:ext cx="2971800" cy="46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9080" rIns="19080" tIns="0" bIns="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888840"/>
                <a:tab algn="l" pos="1778040"/>
                <a:tab algn="l" pos="2666880"/>
                <a:tab algn="l" pos="3556080"/>
                <a:tab algn="l" pos="4444920"/>
                <a:tab algn="l" pos="5334120"/>
                <a:tab algn="l" pos="6222960"/>
                <a:tab algn="l" pos="7112160"/>
                <a:tab algn="l" pos="8001000"/>
                <a:tab algn="l" pos="8889840"/>
                <a:tab algn="l" pos="9779040"/>
                <a:tab algn="l" pos="1066788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"/>
          <p:cNvSpPr/>
          <p:nvPr/>
        </p:nvSpPr>
        <p:spPr>
          <a:xfrm>
            <a:off x="0" y="8683560"/>
            <a:ext cx="2971800" cy="46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5"/>
          <p:cNvSpPr/>
          <p:nvPr/>
        </p:nvSpPr>
        <p:spPr>
          <a:xfrm>
            <a:off x="0" y="-1440"/>
            <a:ext cx="2971800" cy="45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1"/>
          <p:cNvSpPr>
            <a:spLocks noGrp="1"/>
          </p:cNvSpPr>
          <p:nvPr>
            <p:ph type="sldImg"/>
          </p:nvPr>
        </p:nvSpPr>
        <p:spPr>
          <a:xfrm>
            <a:off x="1143000" y="687240"/>
            <a:ext cx="4570560" cy="3427560"/>
          </a:xfrm>
          <a:prstGeom prst="rect">
            <a:avLst/>
          </a:prstGeom>
          <a:ln w="0">
            <a:noFill/>
          </a:ln>
        </p:spPr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6EDAD-1C60-47EF-9BF4-8A98F3DFDD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CB530F-986E-46F0-83A0-095CD9CE0A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662606-8E8C-4ABA-ADF4-21E27FEDE3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810FC-0655-474B-9C65-07ACE9EDF75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A844DD-1180-4856-88C9-6334D6B6F9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3334B5-90B4-48F1-93BF-F263FFD60F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BCE47A-1C61-4AEA-9BB6-4C6725D279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802531-F14D-4DE3-A2DC-E48A32FEB6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9BE2E-B1FF-4FFF-8B42-C8E4DD1588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99F3F3-9728-420E-904B-D537BF5167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71033-8CB8-47AE-8BBA-98B0B066A6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A9A810-A9D6-417A-92E8-EDE9373244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65CBC0-82BA-4C85-810C-55FE129C59E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"/>
          <p:cNvSpPr/>
          <p:nvPr/>
        </p:nvSpPr>
        <p:spPr>
          <a:xfrm>
            <a:off x="533520" y="3773520"/>
            <a:ext cx="8076960" cy="12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80  82 A B C              90                 100 A B C D 10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MN-14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LQMDSLRPEDTGVYFCA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S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L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YFGFP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••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WFA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Y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S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S---AM-Y--R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Q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SNYDYDG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-----------R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Q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SNYDYDG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3"/>
          <p:cNvSpPr/>
          <p:nvPr/>
        </p:nvSpPr>
        <p:spPr>
          <a:xfrm>
            <a:off x="533520" y="990720"/>
            <a:ext cx="8076960" cy="12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1                10                  20                  30                  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MN-14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E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VQLVESGGGVVQPGRSLRLSCS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A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SGF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F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TTYWMS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WVRQ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     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Q-K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Q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G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K---AT---T-S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Y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    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Q---Q----------------------T-S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Y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4"/>
          <p:cNvSpPr/>
          <p:nvPr/>
        </p:nvSpPr>
        <p:spPr>
          <a:xfrm>
            <a:off x="533520" y="2362320"/>
            <a:ext cx="8076960" cy="158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50  52 A              60                  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MN-14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PGKGLEWVA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EIHPDSSTINYAPSLKD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RFTISRDNSKNTL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E-R--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Y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NY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STY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P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-----A----Y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h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Y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NY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STY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P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-----A--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                                       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5"/>
          <p:cNvSpPr/>
          <p:nvPr/>
        </p:nvSpPr>
        <p:spPr>
          <a:xfrm>
            <a:off x="6794640" y="1206360"/>
            <a:ext cx="774720" cy="847800"/>
          </a:xfrm>
          <a:prstGeom prst="rect">
            <a:avLst/>
          </a:prstGeom>
          <a:noFill/>
          <a:ln w="324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6"/>
          <p:cNvSpPr/>
          <p:nvPr/>
        </p:nvSpPr>
        <p:spPr>
          <a:xfrm>
            <a:off x="3581280" y="2581200"/>
            <a:ext cx="2578320" cy="847800"/>
          </a:xfrm>
          <a:prstGeom prst="rect">
            <a:avLst/>
          </a:prstGeom>
          <a:noFill/>
          <a:ln w="324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7"/>
          <p:cNvSpPr/>
          <p:nvPr/>
        </p:nvSpPr>
        <p:spPr>
          <a:xfrm>
            <a:off x="4952880" y="3990960"/>
            <a:ext cx="1889280" cy="874800"/>
          </a:xfrm>
          <a:prstGeom prst="rect">
            <a:avLst/>
          </a:prstGeom>
          <a:noFill/>
          <a:ln w="324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8"/>
          <p:cNvSpPr/>
          <p:nvPr/>
        </p:nvSpPr>
        <p:spPr>
          <a:xfrm>
            <a:off x="533520" y="5181480"/>
            <a:ext cx="8076960" cy="128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103           110   1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MN-14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WGQGTPVTVS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L-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A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H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--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9"/>
          <p:cNvSpPr/>
          <p:nvPr/>
        </p:nvSpPr>
        <p:spPr>
          <a:xfrm>
            <a:off x="154800" y="152280"/>
            <a:ext cx="132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2"/>
          <p:cNvSpPr/>
          <p:nvPr/>
        </p:nvSpPr>
        <p:spPr>
          <a:xfrm>
            <a:off x="496800" y="1447920"/>
            <a:ext cx="8150400" cy="12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1                10                  20                  30                  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MN-14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DIQ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L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TQSPSSLSASVGDRVTITC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K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ASQD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VGTSVA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WYQQ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V----HKFM-T------S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E---A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--------------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E---A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3"/>
          <p:cNvSpPr/>
          <p:nvPr/>
        </p:nvSpPr>
        <p:spPr>
          <a:xfrm>
            <a:off x="460440" y="2971800"/>
            <a:ext cx="8186760" cy="12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50                  60                  70                  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MN-14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GKAPKLLIY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WT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S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TRHT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GVPSRFSGSGSGTD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F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PMingLiU"/>
              </a:rPr>
              <a:t>TFTISSLQ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QS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A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-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D--T---------L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NV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A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--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-----------------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"/>
          <p:cNvSpPr/>
          <p:nvPr/>
        </p:nvSpPr>
        <p:spPr>
          <a:xfrm>
            <a:off x="473040" y="4419720"/>
            <a:ext cx="8197920" cy="12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90          96     100             1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MN-14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EDIATYYCQQYSLY•RSFGGGTKVEIK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D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F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P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T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A-A-L-L-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6002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hR1V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ourier New"/>
              </a:rPr>
              <a:t>K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F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-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P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Times New Roman"/>
              </a:rPr>
              <a:t>L</a:t>
            </a:r>
            <a:r>
              <a:rPr b="1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T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  <a:ea typeface="Courier New"/>
              </a:rPr>
              <a:t>--Q-------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5"/>
          <p:cNvSpPr/>
          <p:nvPr/>
        </p:nvSpPr>
        <p:spPr>
          <a:xfrm>
            <a:off x="5678640" y="1681200"/>
            <a:ext cx="1685880" cy="812880"/>
          </a:xfrm>
          <a:prstGeom prst="rect">
            <a:avLst/>
          </a:prstGeom>
          <a:noFill/>
          <a:ln w="324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6"/>
          <p:cNvSpPr/>
          <p:nvPr/>
        </p:nvSpPr>
        <p:spPr>
          <a:xfrm>
            <a:off x="3403440" y="4630680"/>
            <a:ext cx="1352880" cy="847800"/>
          </a:xfrm>
          <a:prstGeom prst="rect">
            <a:avLst/>
          </a:prstGeom>
          <a:noFill/>
          <a:ln w="324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7"/>
          <p:cNvSpPr/>
          <p:nvPr/>
        </p:nvSpPr>
        <p:spPr>
          <a:xfrm>
            <a:off x="3503520" y="3192480"/>
            <a:ext cx="1074960" cy="852480"/>
          </a:xfrm>
          <a:prstGeom prst="rect">
            <a:avLst/>
          </a:prstGeom>
          <a:noFill/>
          <a:ln w="324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8"/>
          <p:cNvSpPr/>
          <p:nvPr/>
        </p:nvSpPr>
        <p:spPr>
          <a:xfrm>
            <a:off x="612000" y="762120"/>
            <a:ext cx="132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06T16:12:32Z</dcterms:created>
  <dc:creator>yawang</dc:creator>
  <dc:description/>
  <dc:language>en-US</dc:language>
  <cp:lastModifiedBy>yawang</cp:lastModifiedBy>
  <dcterms:modified xsi:type="dcterms:W3CDTF">2012-08-06T16:41:31Z</dcterms:modified>
  <cp:revision>2</cp:revision>
  <dc:subject/>
  <dc:title>Slide 1</dc:title>
</cp:coreProperties>
</file>